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0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60" userDrawn="1">
          <p15:clr>
            <a:srgbClr val="A4A3A4"/>
          </p15:clr>
        </p15:guide>
        <p15:guide id="3" orient="horz" pos="1436" userDrawn="1">
          <p15:clr>
            <a:srgbClr val="A4A3A4"/>
          </p15:clr>
        </p15:guide>
        <p15:guide id="4" orient="horz" pos="4407" userDrawn="1">
          <p15:clr>
            <a:srgbClr val="A4A3A4"/>
          </p15:clr>
        </p15:guide>
        <p15:guide id="5" orient="horz" pos="5677" userDrawn="1">
          <p15:clr>
            <a:srgbClr val="A4A3A4"/>
          </p15:clr>
        </p15:guide>
        <p15:guide id="6" pos="504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3568552-42BF-41B2-A50E-B7B6266727A2}" name="Mireille Vankemmelbeke" initials="MV" userId="S::MireilleVankemmelbeke@scancell.co.uk::e2496c92-8ae2-4817-81db-1e2fdf7923b3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0" d="100"/>
          <a:sy n="50" d="100"/>
        </p:scale>
        <p:origin x="2690" y="34"/>
      </p:cViewPr>
      <p:guideLst>
        <p:guide orient="horz" pos="3840"/>
        <p:guide pos="2160"/>
        <p:guide orient="horz" pos="1436"/>
        <p:guide orient="horz" pos="4407"/>
        <p:guide orient="horz" pos="5677"/>
        <p:guide pos="50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8/10/relationships/authors" Target="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ireille Vankemmelbeke" userId="e2496c92-8ae2-4817-81db-1e2fdf7923b3" providerId="ADAL" clId="{9DB8E981-33ED-48C6-B90F-E774379A8D4C}"/>
    <pc:docChg chg="custSel delSld modSld">
      <pc:chgData name="Mireille Vankemmelbeke" userId="e2496c92-8ae2-4817-81db-1e2fdf7923b3" providerId="ADAL" clId="{9DB8E981-33ED-48C6-B90F-E774379A8D4C}" dt="2024-06-21T15:49:50.253" v="5" actId="478"/>
      <pc:docMkLst>
        <pc:docMk/>
      </pc:docMkLst>
      <pc:sldChg chg="del">
        <pc:chgData name="Mireille Vankemmelbeke" userId="e2496c92-8ae2-4817-81db-1e2fdf7923b3" providerId="ADAL" clId="{9DB8E981-33ED-48C6-B90F-E774379A8D4C}" dt="2024-06-21T15:49:27.399" v="0" actId="47"/>
        <pc:sldMkLst>
          <pc:docMk/>
          <pc:sldMk cId="3935331238" sldId="268"/>
        </pc:sldMkLst>
      </pc:sldChg>
      <pc:sldChg chg="del">
        <pc:chgData name="Mireille Vankemmelbeke" userId="e2496c92-8ae2-4817-81db-1e2fdf7923b3" providerId="ADAL" clId="{9DB8E981-33ED-48C6-B90F-E774379A8D4C}" dt="2024-06-21T15:49:29.265" v="1" actId="47"/>
        <pc:sldMkLst>
          <pc:docMk/>
          <pc:sldMk cId="868960993" sldId="269"/>
        </pc:sldMkLst>
      </pc:sldChg>
      <pc:sldChg chg="delSp modSp mod">
        <pc:chgData name="Mireille Vankemmelbeke" userId="e2496c92-8ae2-4817-81db-1e2fdf7923b3" providerId="ADAL" clId="{9DB8E981-33ED-48C6-B90F-E774379A8D4C}" dt="2024-06-21T15:49:50.253" v="5" actId="478"/>
        <pc:sldMkLst>
          <pc:docMk/>
          <pc:sldMk cId="2268793920" sldId="270"/>
        </pc:sldMkLst>
        <pc:spChg chg="mod">
          <ac:chgData name="Mireille Vankemmelbeke" userId="e2496c92-8ae2-4817-81db-1e2fdf7923b3" providerId="ADAL" clId="{9DB8E981-33ED-48C6-B90F-E774379A8D4C}" dt="2024-06-21T15:49:45.646" v="4" actId="1076"/>
          <ac:spMkLst>
            <pc:docMk/>
            <pc:sldMk cId="2268793920" sldId="270"/>
            <ac:spMk id="3" creationId="{411201C2-C076-747D-F08A-A44B40E18A6D}"/>
          </ac:spMkLst>
        </pc:spChg>
        <pc:spChg chg="del">
          <ac:chgData name="Mireille Vankemmelbeke" userId="e2496c92-8ae2-4817-81db-1e2fdf7923b3" providerId="ADAL" clId="{9DB8E981-33ED-48C6-B90F-E774379A8D4C}" dt="2024-06-21T15:49:35.741" v="2" actId="478"/>
          <ac:spMkLst>
            <pc:docMk/>
            <pc:sldMk cId="2268793920" sldId="270"/>
            <ac:spMk id="4" creationId="{6C679A7D-5300-C36C-0199-33B42D6BEBE0}"/>
          </ac:spMkLst>
        </pc:spChg>
        <pc:spChg chg="del">
          <ac:chgData name="Mireille Vankemmelbeke" userId="e2496c92-8ae2-4817-81db-1e2fdf7923b3" providerId="ADAL" clId="{9DB8E981-33ED-48C6-B90F-E774379A8D4C}" dt="2024-06-21T15:49:35.741" v="2" actId="478"/>
          <ac:spMkLst>
            <pc:docMk/>
            <pc:sldMk cId="2268793920" sldId="270"/>
            <ac:spMk id="5" creationId="{6BAD10FA-2C98-A648-CA57-E529F81BBA0C}"/>
          </ac:spMkLst>
        </pc:spChg>
        <pc:spChg chg="del">
          <ac:chgData name="Mireille Vankemmelbeke" userId="e2496c92-8ae2-4817-81db-1e2fdf7923b3" providerId="ADAL" clId="{9DB8E981-33ED-48C6-B90F-E774379A8D4C}" dt="2024-06-21T15:49:35.741" v="2" actId="478"/>
          <ac:spMkLst>
            <pc:docMk/>
            <pc:sldMk cId="2268793920" sldId="270"/>
            <ac:spMk id="8" creationId="{388F4722-3142-0E4E-7B51-C1AD4808FA62}"/>
          </ac:spMkLst>
        </pc:spChg>
        <pc:spChg chg="del">
          <ac:chgData name="Mireille Vankemmelbeke" userId="e2496c92-8ae2-4817-81db-1e2fdf7923b3" providerId="ADAL" clId="{9DB8E981-33ED-48C6-B90F-E774379A8D4C}" dt="2024-06-21T15:49:35.741" v="2" actId="478"/>
          <ac:spMkLst>
            <pc:docMk/>
            <pc:sldMk cId="2268793920" sldId="270"/>
            <ac:spMk id="9" creationId="{76577009-EBC2-0F5C-D361-900F07FE541F}"/>
          </ac:spMkLst>
        </pc:spChg>
        <pc:spChg chg="del">
          <ac:chgData name="Mireille Vankemmelbeke" userId="e2496c92-8ae2-4817-81db-1e2fdf7923b3" providerId="ADAL" clId="{9DB8E981-33ED-48C6-B90F-E774379A8D4C}" dt="2024-06-21T15:49:50.253" v="5" actId="478"/>
          <ac:spMkLst>
            <pc:docMk/>
            <pc:sldMk cId="2268793920" sldId="270"/>
            <ac:spMk id="19" creationId="{48315DE5-A130-0BA2-72C1-0450A2A5CF23}"/>
          </ac:spMkLst>
        </pc:spChg>
        <pc:picChg chg="del">
          <ac:chgData name="Mireille Vankemmelbeke" userId="e2496c92-8ae2-4817-81db-1e2fdf7923b3" providerId="ADAL" clId="{9DB8E981-33ED-48C6-B90F-E774379A8D4C}" dt="2024-06-21T15:49:35.741" v="2" actId="478"/>
          <ac:picMkLst>
            <pc:docMk/>
            <pc:sldMk cId="2268793920" sldId="270"/>
            <ac:picMk id="2" creationId="{43C713C9-25BA-E672-0179-9E620305EF59}"/>
          </ac:picMkLst>
        </pc:picChg>
        <pc:picChg chg="mod">
          <ac:chgData name="Mireille Vankemmelbeke" userId="e2496c92-8ae2-4817-81db-1e2fdf7923b3" providerId="ADAL" clId="{9DB8E981-33ED-48C6-B90F-E774379A8D4C}" dt="2024-06-21T15:49:45.646" v="4" actId="1076"/>
          <ac:picMkLst>
            <pc:docMk/>
            <pc:sldMk cId="2268793920" sldId="270"/>
            <ac:picMk id="6" creationId="{620BD82B-C7FC-6143-EE6F-A2BE66DCBC12}"/>
          </ac:picMkLst>
        </pc:picChg>
        <pc:picChg chg="del">
          <ac:chgData name="Mireille Vankemmelbeke" userId="e2496c92-8ae2-4817-81db-1e2fdf7923b3" providerId="ADAL" clId="{9DB8E981-33ED-48C6-B90F-E774379A8D4C}" dt="2024-06-21T15:49:35.741" v="2" actId="478"/>
          <ac:picMkLst>
            <pc:docMk/>
            <pc:sldMk cId="2268793920" sldId="270"/>
            <ac:picMk id="10" creationId="{295FA8D2-E6CA-5C56-0855-D3C356A539B3}"/>
          </ac:picMkLst>
        </pc:picChg>
        <pc:picChg chg="del">
          <ac:chgData name="Mireille Vankemmelbeke" userId="e2496c92-8ae2-4817-81db-1e2fdf7923b3" providerId="ADAL" clId="{9DB8E981-33ED-48C6-B90F-E774379A8D4C}" dt="2024-06-21T15:49:35.741" v="2" actId="478"/>
          <ac:picMkLst>
            <pc:docMk/>
            <pc:sldMk cId="2268793920" sldId="270"/>
            <ac:picMk id="12" creationId="{B54F9ADC-933E-3BD5-B1CF-8E6048D4D8E2}"/>
          </ac:picMkLst>
        </pc:picChg>
        <pc:picChg chg="del">
          <ac:chgData name="Mireille Vankemmelbeke" userId="e2496c92-8ae2-4817-81db-1e2fdf7923b3" providerId="ADAL" clId="{9DB8E981-33ED-48C6-B90F-E774379A8D4C}" dt="2024-06-21T15:49:36.324" v="3" actId="478"/>
          <ac:picMkLst>
            <pc:docMk/>
            <pc:sldMk cId="2268793920" sldId="270"/>
            <ac:picMk id="13" creationId="{24512802-B1EB-520D-C5F5-52F1ED5766AA}"/>
          </ac:picMkLst>
        </pc:picChg>
        <pc:picChg chg="del">
          <ac:chgData name="Mireille Vankemmelbeke" userId="e2496c92-8ae2-4817-81db-1e2fdf7923b3" providerId="ADAL" clId="{9DB8E981-33ED-48C6-B90F-E774379A8D4C}" dt="2024-06-21T15:49:50.253" v="5" actId="478"/>
          <ac:picMkLst>
            <pc:docMk/>
            <pc:sldMk cId="2268793920" sldId="270"/>
            <ac:picMk id="21" creationId="{F3403A0F-5911-E5E8-5A09-51B2AAF48C96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07ED1A2-C795-4A89-BC5A-004D576CF3DF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A34F97C-AF6A-4678-A188-E641391358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31473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A34F97C-AF6A-4678-A188-E641391358E4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09724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40817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34315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97030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19088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63236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98543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8744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95993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70211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36878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84850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56388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1">
            <a:extLst>
              <a:ext uri="{FF2B5EF4-FFF2-40B4-BE49-F238E27FC236}">
                <a16:creationId xmlns:a16="http://schemas.microsoft.com/office/drawing/2014/main" id="{1061DE32-896F-447B-5DEA-ACB36D3C14CF}"/>
              </a:ext>
            </a:extLst>
          </p:cNvPr>
          <p:cNvSpPr txBox="1">
            <a:spLocks/>
          </p:cNvSpPr>
          <p:nvPr/>
        </p:nvSpPr>
        <p:spPr>
          <a:xfrm>
            <a:off x="30481" y="2212"/>
            <a:ext cx="5604510" cy="10645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2400" dirty="0"/>
              <a:t>Supplemental Figures</a:t>
            </a:r>
            <a:endParaRPr lang="en-GB" sz="1100" dirty="0"/>
          </a:p>
        </p:txBody>
      </p:sp>
      <p:sp>
        <p:nvSpPr>
          <p:cNvPr id="3" name="TextBox 1">
            <a:extLst>
              <a:ext uri="{FF2B5EF4-FFF2-40B4-BE49-F238E27FC236}">
                <a16:creationId xmlns:a16="http://schemas.microsoft.com/office/drawing/2014/main" id="{411201C2-C076-747D-F08A-A44B40E18A6D}"/>
              </a:ext>
            </a:extLst>
          </p:cNvPr>
          <p:cNvSpPr txBox="1"/>
          <p:nvPr/>
        </p:nvSpPr>
        <p:spPr>
          <a:xfrm>
            <a:off x="0" y="1044223"/>
            <a:ext cx="6656138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GB" sz="900" b="1" dirty="0"/>
              <a:t>Supplemental Figure 10</a:t>
            </a:r>
            <a:r>
              <a:rPr lang="en-GB" sz="900" dirty="0"/>
              <a:t>. Individual tumour growth curves from anti-tumour study testing efficacy of SC134-TCB in combination with Atezolizumab. 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620BD82B-C7FC-6143-EE6F-A2BE66DCBC1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43724" y="1327653"/>
            <a:ext cx="2870257" cy="252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687939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3</Words>
  <Application>Microsoft Office PowerPoint</Application>
  <PresentationFormat>Widescreen</PresentationFormat>
  <Paragraphs>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reille Vankemmelbeke</dc:creator>
  <cp:lastModifiedBy>Mireille Vankemmelbeke</cp:lastModifiedBy>
  <cp:revision>3</cp:revision>
  <dcterms:created xsi:type="dcterms:W3CDTF">2024-03-08T14:10:38Z</dcterms:created>
  <dcterms:modified xsi:type="dcterms:W3CDTF">2024-06-21T15:49:55Z</dcterms:modified>
</cp:coreProperties>
</file>